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  <p:sldId id="258" r:id="rId3"/>
    <p:sldId id="256" r:id="rId4"/>
  </p:sldIdLst>
  <p:sldSz cx="17279938" cy="11520488"/>
  <p:notesSz cx="6858000" cy="9144000"/>
  <p:defaultTextStyle>
    <a:defPPr>
      <a:defRPr lang="ko-KR"/>
    </a:defPPr>
    <a:lvl1pPr marL="0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1pPr>
    <a:lvl2pPr marL="365730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2pPr>
    <a:lvl3pPr marL="731462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3pPr>
    <a:lvl4pPr marL="1097192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4pPr>
    <a:lvl5pPr marL="1462923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5pPr>
    <a:lvl6pPr marL="1828654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6pPr>
    <a:lvl7pPr marL="2194385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7pPr>
    <a:lvl8pPr marL="2560115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8pPr>
    <a:lvl9pPr marL="2925846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34" d="100"/>
          <a:sy n="34" d="100"/>
        </p:scale>
        <p:origin x="138" y="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3&#45380;\penicilllium\RNA%20seq\from%20DNA%20link\20140919_analysys_results\&#48516;&#49437;&#44208;&#44284;_results\2.Functional_Annotation\IPR-1-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3200" b="1" i="0" u="sng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3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/defense-related </a:t>
            </a:r>
            <a:r>
              <a:rPr lang="en-US" altLang="ko-KR" sz="3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</a:p>
        </c:rich>
      </c:tx>
      <c:layout>
        <c:manualLayout>
          <c:xMode val="edge"/>
          <c:yMode val="edge"/>
          <c:x val="0.3105407558320944"/>
          <c:y val="2.19478737997256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3200" b="1" i="0" u="sng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45998685828607083"/>
          <c:y val="0.19658870999334038"/>
          <c:w val="0.51514842237690006"/>
          <c:h val="0.59917468649752115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5!$A$1</c:f>
              <c:strCache>
                <c:ptCount val="1"/>
                <c:pt idx="0">
                  <c:v>ROS/defese-related gen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5!$D$3:$D$10</c:f>
              <c:strCache>
                <c:ptCount val="8"/>
                <c:pt idx="0">
                  <c:v>Dyp-type peroxidase (446037)</c:v>
                </c:pt>
                <c:pt idx="1">
                  <c:v>Chloroperoxidase (332379)</c:v>
                </c:pt>
                <c:pt idx="2">
                  <c:v>Chloroperoxidase (443906)</c:v>
                </c:pt>
                <c:pt idx="3">
                  <c:v>Glutathione S-transferase, C-terminal (344745)</c:v>
                </c:pt>
                <c:pt idx="4">
                  <c:v>Glutathione S-transferase, C-terminal-like (372157)</c:v>
                </c:pt>
                <c:pt idx="5">
                  <c:v>Glutathione S-transferase, C-terminal-like (439045)</c:v>
                </c:pt>
                <c:pt idx="6">
                  <c:v>Manganese and iron superoxide dismutase (372225)</c:v>
                </c:pt>
                <c:pt idx="7">
                  <c:v>Catalase (324436)</c:v>
                </c:pt>
              </c:strCache>
            </c:strRef>
          </c:cat>
          <c:val>
            <c:numRef>
              <c:f>Sheet5!$E$3:$E$10</c:f>
              <c:numCache>
                <c:formatCode>General</c:formatCode>
                <c:ptCount val="8"/>
                <c:pt idx="0">
                  <c:v>4.6523700000000003</c:v>
                </c:pt>
                <c:pt idx="1">
                  <c:v>2.52536</c:v>
                </c:pt>
                <c:pt idx="2">
                  <c:v>5.01722</c:v>
                </c:pt>
                <c:pt idx="3">
                  <c:v>-3.7739099999999999</c:v>
                </c:pt>
                <c:pt idx="4">
                  <c:v>-5.2370700000000001</c:v>
                </c:pt>
                <c:pt idx="5">
                  <c:v>-2.23502</c:v>
                </c:pt>
                <c:pt idx="6">
                  <c:v>-3.8683800000000002</c:v>
                </c:pt>
                <c:pt idx="7">
                  <c:v>-4.132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317594064"/>
        <c:axId val="317591320"/>
      </c:barChart>
      <c:catAx>
        <c:axId val="3175940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20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pr Description (#proteinId)</a:t>
                </a:r>
                <a:endParaRPr lang="ko-KR" sz="20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7532954128837593E-3"/>
              <c:y val="0.195878111383584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17591320"/>
        <c:crosses val="autoZero"/>
        <c:auto val="1"/>
        <c:lblAlgn val="ctr"/>
        <c:lblOffset val="100"/>
        <c:noMultiLvlLbl val="0"/>
      </c:catAx>
      <c:valAx>
        <c:axId val="317591320"/>
        <c:scaling>
          <c:orientation val="minMax"/>
          <c:max val="8"/>
          <c:min val="-8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8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og2 (SSF/SmF)</a:t>
                </a:r>
                <a:endParaRPr lang="ko-KR" sz="18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63953776407319696"/>
              <c:y val="0.916172083427843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17594064"/>
        <c:crosses val="autoZero"/>
        <c:crossBetween val="between"/>
        <c:majorUnit val="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+mn-ea"/>
          <a:ea typeface="+mn-ea"/>
          <a:cs typeface="Arial Unicode MS" panose="020B0604020202020204" pitchFamily="50" charset="-127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95996" y="1885414"/>
            <a:ext cx="14687947" cy="4010837"/>
          </a:xfrm>
        </p:spPr>
        <p:txBody>
          <a:bodyPr anchor="b"/>
          <a:lstStyle>
            <a:lvl1pPr algn="ctr">
              <a:defRPr sz="10079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59992" y="6050924"/>
            <a:ext cx="12959954" cy="2781450"/>
          </a:xfrm>
        </p:spPr>
        <p:txBody>
          <a:bodyPr/>
          <a:lstStyle>
            <a:lvl1pPr marL="0" indent="0" algn="ctr">
              <a:buNone/>
              <a:defRPr sz="4032"/>
            </a:lvl1pPr>
            <a:lvl2pPr marL="768050" indent="0" algn="ctr">
              <a:buNone/>
              <a:defRPr sz="3360"/>
            </a:lvl2pPr>
            <a:lvl3pPr marL="1536101" indent="0" algn="ctr">
              <a:buNone/>
              <a:defRPr sz="3024"/>
            </a:lvl3pPr>
            <a:lvl4pPr marL="2304151" indent="0" algn="ctr">
              <a:buNone/>
              <a:defRPr sz="2688"/>
            </a:lvl4pPr>
            <a:lvl5pPr marL="3072201" indent="0" algn="ctr">
              <a:buNone/>
              <a:defRPr sz="2688"/>
            </a:lvl5pPr>
            <a:lvl6pPr marL="3840251" indent="0" algn="ctr">
              <a:buNone/>
              <a:defRPr sz="2688"/>
            </a:lvl6pPr>
            <a:lvl7pPr marL="4608302" indent="0" algn="ctr">
              <a:buNone/>
              <a:defRPr sz="2688"/>
            </a:lvl7pPr>
            <a:lvl8pPr marL="5376352" indent="0" algn="ctr">
              <a:buNone/>
              <a:defRPr sz="2688"/>
            </a:lvl8pPr>
            <a:lvl9pPr marL="6144402" indent="0" algn="ctr">
              <a:buNone/>
              <a:defRPr sz="2688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2708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7349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365956" y="613359"/>
            <a:ext cx="3725987" cy="9763081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87997" y="613359"/>
            <a:ext cx="10961961" cy="9763081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9333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9126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8996" y="2872125"/>
            <a:ext cx="14903947" cy="4792202"/>
          </a:xfrm>
        </p:spPr>
        <p:txBody>
          <a:bodyPr anchor="b"/>
          <a:lstStyle>
            <a:lvl1pPr>
              <a:defRPr sz="10079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8996" y="7709663"/>
            <a:ext cx="14903947" cy="2520106"/>
          </a:xfrm>
        </p:spPr>
        <p:txBody>
          <a:bodyPr/>
          <a:lstStyle>
            <a:lvl1pPr marL="0" indent="0">
              <a:buNone/>
              <a:defRPr sz="4032">
                <a:solidFill>
                  <a:schemeClr val="tx1"/>
                </a:solidFill>
              </a:defRPr>
            </a:lvl1pPr>
            <a:lvl2pPr marL="76805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2pPr>
            <a:lvl3pPr marL="1536101" indent="0">
              <a:buNone/>
              <a:defRPr sz="3024">
                <a:solidFill>
                  <a:schemeClr val="tx1">
                    <a:tint val="75000"/>
                  </a:schemeClr>
                </a:solidFill>
              </a:defRPr>
            </a:lvl3pPr>
            <a:lvl4pPr marL="2304151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4pPr>
            <a:lvl5pPr marL="3072201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5pPr>
            <a:lvl6pPr marL="3840251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6pPr>
            <a:lvl7pPr marL="460830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7pPr>
            <a:lvl8pPr marL="537635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8pPr>
            <a:lvl9pPr marL="614440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5085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87996" y="3066796"/>
            <a:ext cx="7343974" cy="730964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747968" y="3066796"/>
            <a:ext cx="7343974" cy="730964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1309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6" y="613362"/>
            <a:ext cx="14903947" cy="222676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90248" y="2824120"/>
            <a:ext cx="7310223" cy="138405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050" indent="0">
              <a:buNone/>
              <a:defRPr sz="3360" b="1"/>
            </a:lvl2pPr>
            <a:lvl3pPr marL="1536101" indent="0">
              <a:buNone/>
              <a:defRPr sz="3024" b="1"/>
            </a:lvl3pPr>
            <a:lvl4pPr marL="2304151" indent="0">
              <a:buNone/>
              <a:defRPr sz="2688" b="1"/>
            </a:lvl4pPr>
            <a:lvl5pPr marL="3072201" indent="0">
              <a:buNone/>
              <a:defRPr sz="2688" b="1"/>
            </a:lvl5pPr>
            <a:lvl6pPr marL="3840251" indent="0">
              <a:buNone/>
              <a:defRPr sz="2688" b="1"/>
            </a:lvl6pPr>
            <a:lvl7pPr marL="4608302" indent="0">
              <a:buNone/>
              <a:defRPr sz="2688" b="1"/>
            </a:lvl7pPr>
            <a:lvl8pPr marL="5376352" indent="0">
              <a:buNone/>
              <a:defRPr sz="2688" b="1"/>
            </a:lvl8pPr>
            <a:lvl9pPr marL="6144402" indent="0">
              <a:buNone/>
              <a:defRPr sz="2688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90248" y="4208178"/>
            <a:ext cx="7310223" cy="618959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747970" y="2824120"/>
            <a:ext cx="7346224" cy="138405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050" indent="0">
              <a:buNone/>
              <a:defRPr sz="3360" b="1"/>
            </a:lvl2pPr>
            <a:lvl3pPr marL="1536101" indent="0">
              <a:buNone/>
              <a:defRPr sz="3024" b="1"/>
            </a:lvl3pPr>
            <a:lvl4pPr marL="2304151" indent="0">
              <a:buNone/>
              <a:defRPr sz="2688" b="1"/>
            </a:lvl4pPr>
            <a:lvl5pPr marL="3072201" indent="0">
              <a:buNone/>
              <a:defRPr sz="2688" b="1"/>
            </a:lvl5pPr>
            <a:lvl6pPr marL="3840251" indent="0">
              <a:buNone/>
              <a:defRPr sz="2688" b="1"/>
            </a:lvl6pPr>
            <a:lvl7pPr marL="4608302" indent="0">
              <a:buNone/>
              <a:defRPr sz="2688" b="1"/>
            </a:lvl7pPr>
            <a:lvl8pPr marL="5376352" indent="0">
              <a:buNone/>
              <a:defRPr sz="2688" b="1"/>
            </a:lvl8pPr>
            <a:lvl9pPr marL="6144402" indent="0">
              <a:buNone/>
              <a:defRPr sz="2688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747970" y="4208178"/>
            <a:ext cx="7346224" cy="618959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7023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5399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162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6" y="768032"/>
            <a:ext cx="5573230" cy="268811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346224" y="1658740"/>
            <a:ext cx="8747969" cy="8187013"/>
          </a:xfrm>
        </p:spPr>
        <p:txBody>
          <a:bodyPr/>
          <a:lstStyle>
            <a:lvl1pPr>
              <a:defRPr sz="5376"/>
            </a:lvl1pPr>
            <a:lvl2pPr>
              <a:defRPr sz="4704"/>
            </a:lvl2pPr>
            <a:lvl3pPr>
              <a:defRPr sz="4032"/>
            </a:lvl3pPr>
            <a:lvl4pPr>
              <a:defRPr sz="3360"/>
            </a:lvl4pPr>
            <a:lvl5pPr>
              <a:defRPr sz="3360"/>
            </a:lvl5pPr>
            <a:lvl6pPr>
              <a:defRPr sz="3360"/>
            </a:lvl6pPr>
            <a:lvl7pPr>
              <a:defRPr sz="3360"/>
            </a:lvl7pPr>
            <a:lvl8pPr>
              <a:defRPr sz="3360"/>
            </a:lvl8pPr>
            <a:lvl9pPr>
              <a:defRPr sz="336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0246" y="3456146"/>
            <a:ext cx="5573230" cy="6402939"/>
          </a:xfrm>
        </p:spPr>
        <p:txBody>
          <a:bodyPr/>
          <a:lstStyle>
            <a:lvl1pPr marL="0" indent="0">
              <a:buNone/>
              <a:defRPr sz="2688"/>
            </a:lvl1pPr>
            <a:lvl2pPr marL="768050" indent="0">
              <a:buNone/>
              <a:defRPr sz="2352"/>
            </a:lvl2pPr>
            <a:lvl3pPr marL="1536101" indent="0">
              <a:buNone/>
              <a:defRPr sz="2016"/>
            </a:lvl3pPr>
            <a:lvl4pPr marL="2304151" indent="0">
              <a:buNone/>
              <a:defRPr sz="1680"/>
            </a:lvl4pPr>
            <a:lvl5pPr marL="3072201" indent="0">
              <a:buNone/>
              <a:defRPr sz="1680"/>
            </a:lvl5pPr>
            <a:lvl6pPr marL="3840251" indent="0">
              <a:buNone/>
              <a:defRPr sz="1680"/>
            </a:lvl6pPr>
            <a:lvl7pPr marL="4608302" indent="0">
              <a:buNone/>
              <a:defRPr sz="1680"/>
            </a:lvl7pPr>
            <a:lvl8pPr marL="5376352" indent="0">
              <a:buNone/>
              <a:defRPr sz="1680"/>
            </a:lvl8pPr>
            <a:lvl9pPr marL="6144402" indent="0">
              <a:buNone/>
              <a:defRPr sz="168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7307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6" y="768032"/>
            <a:ext cx="5573230" cy="268811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346224" y="1658740"/>
            <a:ext cx="8747969" cy="8187013"/>
          </a:xfrm>
        </p:spPr>
        <p:txBody>
          <a:bodyPr anchor="t"/>
          <a:lstStyle>
            <a:lvl1pPr marL="0" indent="0">
              <a:buNone/>
              <a:defRPr sz="5376"/>
            </a:lvl1pPr>
            <a:lvl2pPr marL="768050" indent="0">
              <a:buNone/>
              <a:defRPr sz="4704"/>
            </a:lvl2pPr>
            <a:lvl3pPr marL="1536101" indent="0">
              <a:buNone/>
              <a:defRPr sz="4032"/>
            </a:lvl3pPr>
            <a:lvl4pPr marL="2304151" indent="0">
              <a:buNone/>
              <a:defRPr sz="3360"/>
            </a:lvl4pPr>
            <a:lvl5pPr marL="3072201" indent="0">
              <a:buNone/>
              <a:defRPr sz="3360"/>
            </a:lvl5pPr>
            <a:lvl6pPr marL="3840251" indent="0">
              <a:buNone/>
              <a:defRPr sz="3360"/>
            </a:lvl6pPr>
            <a:lvl7pPr marL="4608302" indent="0">
              <a:buNone/>
              <a:defRPr sz="3360"/>
            </a:lvl7pPr>
            <a:lvl8pPr marL="5376352" indent="0">
              <a:buNone/>
              <a:defRPr sz="3360"/>
            </a:lvl8pPr>
            <a:lvl9pPr marL="6144402" indent="0">
              <a:buNone/>
              <a:defRPr sz="336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0246" y="3456146"/>
            <a:ext cx="5573230" cy="6402939"/>
          </a:xfrm>
        </p:spPr>
        <p:txBody>
          <a:bodyPr/>
          <a:lstStyle>
            <a:lvl1pPr marL="0" indent="0">
              <a:buNone/>
              <a:defRPr sz="2688"/>
            </a:lvl1pPr>
            <a:lvl2pPr marL="768050" indent="0">
              <a:buNone/>
              <a:defRPr sz="2352"/>
            </a:lvl2pPr>
            <a:lvl3pPr marL="1536101" indent="0">
              <a:buNone/>
              <a:defRPr sz="2016"/>
            </a:lvl3pPr>
            <a:lvl4pPr marL="2304151" indent="0">
              <a:buNone/>
              <a:defRPr sz="1680"/>
            </a:lvl4pPr>
            <a:lvl5pPr marL="3072201" indent="0">
              <a:buNone/>
              <a:defRPr sz="1680"/>
            </a:lvl5pPr>
            <a:lvl6pPr marL="3840251" indent="0">
              <a:buNone/>
              <a:defRPr sz="1680"/>
            </a:lvl6pPr>
            <a:lvl7pPr marL="4608302" indent="0">
              <a:buNone/>
              <a:defRPr sz="1680"/>
            </a:lvl7pPr>
            <a:lvl8pPr marL="5376352" indent="0">
              <a:buNone/>
              <a:defRPr sz="1680"/>
            </a:lvl8pPr>
            <a:lvl9pPr marL="6144402" indent="0">
              <a:buNone/>
              <a:defRPr sz="168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5240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87996" y="613362"/>
            <a:ext cx="14903947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87996" y="3066796"/>
            <a:ext cx="14903947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87996" y="10677788"/>
            <a:ext cx="388798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723980" y="10677788"/>
            <a:ext cx="5831979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203956" y="10677788"/>
            <a:ext cx="388798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1458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36101" rtl="0" eaLnBrk="1" latinLnBrk="1" hangingPunct="1">
        <a:lnSpc>
          <a:spcPct val="90000"/>
        </a:lnSpc>
        <a:spcBef>
          <a:spcPct val="0"/>
        </a:spcBef>
        <a:buNone/>
        <a:defRPr sz="73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4025" indent="-384025" algn="l" defTabSz="1536101" rtl="0" eaLnBrk="1" latinLnBrk="1" hangingPunct="1">
        <a:lnSpc>
          <a:spcPct val="90000"/>
        </a:lnSpc>
        <a:spcBef>
          <a:spcPts val="1680"/>
        </a:spcBef>
        <a:buFont typeface="Arial" panose="020B0604020202020204" pitchFamily="34" charset="0"/>
        <a:buChar char="•"/>
        <a:defRPr sz="4704" kern="1200">
          <a:solidFill>
            <a:schemeClr val="tx1"/>
          </a:solidFill>
          <a:latin typeface="+mn-lt"/>
          <a:ea typeface="+mn-ea"/>
          <a:cs typeface="+mn-cs"/>
        </a:defRPr>
      </a:lvl1pPr>
      <a:lvl2pPr marL="1152075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4032" kern="1200">
          <a:solidFill>
            <a:schemeClr val="tx1"/>
          </a:solidFill>
          <a:latin typeface="+mn-lt"/>
          <a:ea typeface="+mn-ea"/>
          <a:cs typeface="+mn-cs"/>
        </a:defRPr>
      </a:lvl2pPr>
      <a:lvl3pPr marL="1920126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688176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456226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4224277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992327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760377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528427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1pPr>
      <a:lvl2pPr marL="768050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536101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3pPr>
      <a:lvl4pPr marL="2304151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072201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3840251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608302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376352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144402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512359" y="10225090"/>
            <a:ext cx="138890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/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Chromatogram of </a:t>
            </a:r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ko-KR" sz="2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ansum</a:t>
            </a:r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815 in </a:t>
            </a:r>
            <a:r>
              <a:rPr lang="en-US" altLang="ko-KR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F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SF by UPLC-Q-TOF-MS analysis in positive mode.</a:t>
            </a:r>
            <a:r>
              <a:rPr lang="en-US" altLang="ko-K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F</a:t>
            </a:r>
            <a:r>
              <a:rPr lang="en-US" altLang="ko-K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ubmerged fermentation, SSF: Solid-state fermentation.</a:t>
            </a:r>
            <a:endParaRPr lang="ko-KR" altLang="ko-KR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" name="그룹 24"/>
          <p:cNvGrpSpPr/>
          <p:nvPr/>
        </p:nvGrpSpPr>
        <p:grpSpPr>
          <a:xfrm>
            <a:off x="1578700" y="531176"/>
            <a:ext cx="13589582" cy="9347933"/>
            <a:chOff x="1578700" y="531176"/>
            <a:chExt cx="13589582" cy="9347933"/>
          </a:xfrm>
        </p:grpSpPr>
        <p:pic>
          <p:nvPicPr>
            <p:cNvPr id="5" name="그림 4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78700" y="1370657"/>
              <a:ext cx="6419947" cy="8508452"/>
            </a:xfrm>
            <a:prstGeom prst="rect">
              <a:avLst/>
            </a:prstGeom>
          </p:spPr>
        </p:pic>
        <p:pic>
          <p:nvPicPr>
            <p:cNvPr id="6" name="그림 5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748335" y="1370657"/>
              <a:ext cx="6419947" cy="8508452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9022436" y="1689440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808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 day</a:t>
              </a:r>
              <a:endParaRPr lang="ko-KR" altLang="en-US" sz="1800" b="1" dirty="0">
                <a:solidFill>
                  <a:srgbClr val="80808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9022436" y="2696191"/>
              <a:ext cx="8386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  day</a:t>
              </a:r>
              <a:endParaRPr lang="ko-KR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022436" y="3755313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FFAD5B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 day</a:t>
              </a:r>
              <a:endParaRPr lang="ko-KR" altLang="en-US" sz="1800" b="1" dirty="0">
                <a:solidFill>
                  <a:srgbClr val="FFAD5B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022436" y="4762081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FFD7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 day</a:t>
              </a:r>
              <a:endParaRPr lang="ko-KR" altLang="en-US" sz="1800" b="1" dirty="0">
                <a:solidFill>
                  <a:srgbClr val="FFD7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9022436" y="5806716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0055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 day</a:t>
              </a:r>
              <a:endParaRPr lang="ko-KR" altLang="en-US" sz="1800" b="1" dirty="0">
                <a:solidFill>
                  <a:srgbClr val="0055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9022436" y="6839652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 day</a:t>
              </a:r>
              <a:endParaRPr lang="ko-KR" altLang="en-US" sz="1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9022436" y="7872601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800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 day</a:t>
              </a:r>
              <a:endParaRPr lang="ko-KR" altLang="en-US" sz="1800" b="1" dirty="0">
                <a:solidFill>
                  <a:srgbClr val="80008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9022436" y="8879351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 day</a:t>
              </a:r>
              <a:endParaRPr lang="ko-KR" altLang="en-US" sz="1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28151" y="1726765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808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 day</a:t>
              </a:r>
              <a:endParaRPr lang="ko-KR" altLang="en-US" sz="1800" b="1" dirty="0">
                <a:solidFill>
                  <a:srgbClr val="80808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28151" y="2733516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 day</a:t>
              </a:r>
              <a:endParaRPr lang="ko-KR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828151" y="3792637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FFAD5B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 day</a:t>
              </a:r>
              <a:endParaRPr lang="ko-KR" altLang="en-US" sz="1800" b="1" dirty="0">
                <a:solidFill>
                  <a:srgbClr val="FFAD5B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828151" y="4799406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FFD7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 day</a:t>
              </a:r>
              <a:endParaRPr lang="ko-KR" altLang="en-US" sz="1800" b="1" dirty="0">
                <a:solidFill>
                  <a:srgbClr val="FFD7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828151" y="5844040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0055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 day</a:t>
              </a:r>
              <a:endParaRPr lang="ko-KR" altLang="en-US" sz="1800" b="1" dirty="0">
                <a:solidFill>
                  <a:srgbClr val="0055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828151" y="6876977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 day</a:t>
              </a:r>
              <a:endParaRPr lang="ko-KR" altLang="en-US" sz="1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828151" y="7909926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800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 day</a:t>
              </a:r>
              <a:endParaRPr lang="ko-KR" altLang="en-US" sz="1800" b="1" dirty="0">
                <a:solidFill>
                  <a:srgbClr val="80008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828151" y="8916676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 day</a:t>
              </a:r>
              <a:endParaRPr lang="ko-KR" altLang="en-US" sz="1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664207" y="531176"/>
              <a:ext cx="267893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mF</a:t>
              </a:r>
              <a:r>
                <a:rPr lang="en-US" altLang="ko-KR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ondition</a:t>
              </a:r>
              <a:endParaRPr lang="ko-KR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8834350" y="531176"/>
              <a:ext cx="25987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F condition</a:t>
              </a:r>
              <a:endParaRPr lang="ko-KR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402534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324272" y="6275295"/>
            <a:ext cx="10903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Fig.</a:t>
            </a:r>
            <a:endParaRPr lang="ko-KR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7994541"/>
              </p:ext>
            </p:extLst>
          </p:nvPr>
        </p:nvGraphicFramePr>
        <p:xfrm>
          <a:off x="2492188" y="3544701"/>
          <a:ext cx="12676093" cy="39139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139888" y="7948055"/>
            <a:ext cx="132076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g. Differentially expressed ROS/defense-related genes in SSF and </a:t>
            </a:r>
            <a:r>
              <a:rPr lang="en-US" altLang="ko-KR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F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undance values (log2 SSF/</a:t>
            </a:r>
            <a:r>
              <a:rPr lang="en-US" altLang="ko-KR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F</a:t>
            </a:r>
            <a:r>
              <a:rPr lang="en-US" altLang="ko-K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ranscripts with significant variations (log2 SSF/</a:t>
            </a:r>
            <a:r>
              <a:rPr lang="en-US" altLang="ko-KR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F</a:t>
            </a:r>
            <a:r>
              <a:rPr lang="en-US" altLang="ko-K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 greater than 1) are shown.</a:t>
            </a:r>
            <a:endParaRPr lang="ko-KR" altLang="ko-KR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5383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/>
          <p:cNvGrpSpPr/>
          <p:nvPr/>
        </p:nvGrpSpPr>
        <p:grpSpPr>
          <a:xfrm>
            <a:off x="281149" y="183832"/>
            <a:ext cx="16697956" cy="11295092"/>
            <a:chOff x="234455" y="525370"/>
            <a:chExt cx="16697956" cy="11295092"/>
          </a:xfrm>
        </p:grpSpPr>
        <p:graphicFrame>
          <p:nvGraphicFramePr>
            <p:cNvPr id="4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12135507"/>
                </p:ext>
              </p:extLst>
            </p:nvPr>
          </p:nvGraphicFramePr>
          <p:xfrm>
            <a:off x="1074088" y="725425"/>
            <a:ext cx="10282237" cy="11095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1" name="CS ChemDraw Drawing" r:id="rId3" imgW="15583958" imgH="16817102" progId="ChemDraw.Document.6.0">
                    <p:embed/>
                  </p:oleObj>
                </mc:Choice>
                <mc:Fallback>
                  <p:oleObj name="CS ChemDraw Drawing" r:id="rId3" imgW="15583958" imgH="16817102" progId="ChemDraw.Document.6.0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074088" y="725425"/>
                          <a:ext cx="10282237" cy="110950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13686083"/>
                </p:ext>
              </p:extLst>
            </p:nvPr>
          </p:nvGraphicFramePr>
          <p:xfrm>
            <a:off x="11734936" y="737432"/>
            <a:ext cx="5197475" cy="5740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2" name="CS ChemDraw Drawing" r:id="rId5" imgW="8732308" imgH="9646563" progId="ChemDraw.Document.6.0">
                    <p:embed/>
                  </p:oleObj>
                </mc:Choice>
                <mc:Fallback>
                  <p:oleObj name="CS ChemDraw Drawing" r:id="rId5" imgW="8732308" imgH="9646563" progId="ChemDraw.Document.6.0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734936" y="737432"/>
                          <a:ext cx="5197475" cy="57404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234455" y="525370"/>
              <a:ext cx="54053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1478941" y="525370"/>
              <a:ext cx="54053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573493" y="10148047"/>
            <a:ext cx="840561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. Biosynthesis pathway of </a:t>
            </a:r>
            <a:r>
              <a:rPr lang="en-US" altLang="ko-KR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rastin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</a:t>
            </a:r>
            <a:r>
              <a:rPr lang="en-US" altLang="ko-KR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zaphilones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series.</a:t>
            </a:r>
            <a:endParaRPr lang="ko-KR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6938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137</Words>
  <Application>Microsoft Office PowerPoint</Application>
  <PresentationFormat>사용자 지정</PresentationFormat>
  <Paragraphs>27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Times New Roman</vt:lpstr>
      <vt:lpstr>Office 테마</vt:lpstr>
      <vt:lpstr>CS ChemDraw Drawing</vt:lpstr>
      <vt:lpstr>PowerPoint 프레젠테이션</vt:lpstr>
      <vt:lpstr>PowerPoint 프레젠테이션</vt:lpstr>
      <vt:lpstr>PowerPoint 프레젠테이션</vt:lpstr>
    </vt:vector>
  </TitlesOfParts>
  <Company>Microsoft Corpor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EMIN PARK</dc:creator>
  <cp:lastModifiedBy>HYEMIN PARK</cp:lastModifiedBy>
  <cp:revision>4</cp:revision>
  <dcterms:created xsi:type="dcterms:W3CDTF">2016-01-08T09:02:14Z</dcterms:created>
  <dcterms:modified xsi:type="dcterms:W3CDTF">2016-01-29T06:44:28Z</dcterms:modified>
</cp:coreProperties>
</file>